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FFC47B-A9DD-43F1-B38D-04B2C739268F}" v="1" dt="2025-11-21T17:30:18.8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54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han Moran" userId="30256bc4-a161-4226-a2d6-4e8766bd09d0" providerId="ADAL" clId="{8B0668C6-C7D0-4AFB-9B8E-773148CE68EF}"/>
    <pc:docChg chg="addSld delSld modSld">
      <pc:chgData name="Meghan Moran" userId="30256bc4-a161-4226-a2d6-4e8766bd09d0" providerId="ADAL" clId="{8B0668C6-C7D0-4AFB-9B8E-773148CE68EF}" dt="2025-11-21T17:30:20.725" v="1" actId="47"/>
      <pc:docMkLst>
        <pc:docMk/>
      </pc:docMkLst>
      <pc:sldChg chg="add">
        <pc:chgData name="Meghan Moran" userId="30256bc4-a161-4226-a2d6-4e8766bd09d0" providerId="ADAL" clId="{8B0668C6-C7D0-4AFB-9B8E-773148CE68EF}" dt="2025-11-21T17:30:18.880" v="0"/>
        <pc:sldMkLst>
          <pc:docMk/>
          <pc:sldMk cId="1329570729" sldId="369"/>
        </pc:sldMkLst>
      </pc:sldChg>
      <pc:sldChg chg="del">
        <pc:chgData name="Meghan Moran" userId="30256bc4-a161-4226-a2d6-4e8766bd09d0" providerId="ADAL" clId="{8B0668C6-C7D0-4AFB-9B8E-773148CE68EF}" dt="2025-11-21T17:30:20.725" v="1" actId="47"/>
        <pc:sldMkLst>
          <pc:docMk/>
          <pc:sldMk cId="2795397606" sldId="37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039" y="1519515"/>
            <a:ext cx="3641001" cy="4335078"/>
          </a:xfrm>
          <a:prstGeom prst="rect">
            <a:avLst/>
          </a:prstGeom>
          <a:ln>
            <a:noFill/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6686" y="1519515"/>
            <a:ext cx="3641001" cy="4335078"/>
          </a:xfrm>
          <a:prstGeom prst="rect">
            <a:avLst/>
          </a:prstGeom>
          <a:ln>
            <a:noFill/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36333" y="1519515"/>
            <a:ext cx="3623973" cy="4314804"/>
          </a:xfrm>
          <a:prstGeom prst="rect">
            <a:avLst/>
          </a:prstGeom>
          <a:ln>
            <a:noFill/>
          </a:ln>
        </p:spPr>
      </p:pic>
      <p:sp>
        <p:nvSpPr>
          <p:cNvPr id="15" name="TextBox 14"/>
          <p:cNvSpPr txBox="1"/>
          <p:nvPr/>
        </p:nvSpPr>
        <p:spPr>
          <a:xfrm>
            <a:off x="704888" y="1219620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636995" y="1219620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17" name="Left Bracket 16"/>
          <p:cNvSpPr/>
          <p:nvPr/>
        </p:nvSpPr>
        <p:spPr>
          <a:xfrm rot="5400000">
            <a:off x="2031010" y="-490759"/>
            <a:ext cx="267672" cy="35789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4549850" y="1241817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481957" y="1241817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20" name="Left Bracket 19"/>
          <p:cNvSpPr/>
          <p:nvPr/>
        </p:nvSpPr>
        <p:spPr>
          <a:xfrm rot="5400000">
            <a:off x="5875972" y="-468562"/>
            <a:ext cx="267672" cy="35789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8377660" y="1241817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0309767" y="1241817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23" name="Left Bracket 22"/>
          <p:cNvSpPr/>
          <p:nvPr/>
        </p:nvSpPr>
        <p:spPr>
          <a:xfrm rot="5400000">
            <a:off x="9703782" y="-468562"/>
            <a:ext cx="267672" cy="35789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925053" y="1219620"/>
            <a:ext cx="43415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713443" y="1211738"/>
            <a:ext cx="393056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681544" y="1219619"/>
            <a:ext cx="492443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746329" y="5834319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71897" y="5854593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411764" y="5861872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31" name="Rectangle 30"/>
          <p:cNvSpPr/>
          <p:nvPr/>
        </p:nvSpPr>
        <p:spPr>
          <a:xfrm>
            <a:off x="161358" y="74421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4811273" y="753002"/>
            <a:ext cx="2197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ximal Ileum- CFA</a:t>
            </a:r>
          </a:p>
        </p:txBody>
      </p:sp>
    </p:spTree>
    <p:extLst>
      <p:ext uri="{BB962C8B-B14F-4D97-AF65-F5344CB8AC3E}">
        <p14:creationId xmlns:p14="http://schemas.microsoft.com/office/powerpoint/2010/main" val="1329570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1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18</cp:revision>
  <dcterms:created xsi:type="dcterms:W3CDTF">2025-11-21T17:16:35Z</dcterms:created>
  <dcterms:modified xsi:type="dcterms:W3CDTF">2025-11-21T17:30:22Z</dcterms:modified>
</cp:coreProperties>
</file>